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4" r:id="rId2"/>
  </p:sldIdLst>
  <p:sldSz cx="9144000" cy="6858000" type="screen4x3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99"/>
    <a:srgbClr val="FF3300"/>
    <a:srgbClr val="FFFF99"/>
    <a:srgbClr val="CC6600"/>
    <a:srgbClr val="0000FF"/>
    <a:srgbClr val="0000CC"/>
    <a:srgbClr val="80008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46" autoAdjust="0"/>
    <p:restoredTop sz="95627" autoAdjust="0"/>
  </p:normalViewPr>
  <p:slideViewPr>
    <p:cSldViewPr snapToGrid="0">
      <p:cViewPr varScale="1">
        <p:scale>
          <a:sx n="108" d="100"/>
          <a:sy n="108" d="100"/>
        </p:scale>
        <p:origin x="191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quarter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9EDB9036-A0C4-4B0A-A2DF-8A14D22382B7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2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3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CC95C0EA-AF05-437B-8E48-5682A51AA75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14655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D136F960-4483-4BB0-9C1C-198FAC25D0E5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47775" y="1279525"/>
            <a:ext cx="4603750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91" tIns="47745" rIns="95491" bIns="47745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09930" y="4925408"/>
            <a:ext cx="5679440" cy="4029879"/>
          </a:xfrm>
          <a:prstGeom prst="rect">
            <a:avLst/>
          </a:prstGeom>
        </p:spPr>
        <p:txBody>
          <a:bodyPr vert="horz" lIns="95491" tIns="47745" rIns="95491" bIns="47745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1BB30AF6-225D-4C3C-968F-215DC2620C9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9383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6927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00752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0285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19101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58359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2882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636365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44784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5207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30168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dirty="0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64401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39992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2"/>
          <p:cNvGrpSpPr/>
          <p:nvPr/>
        </p:nvGrpSpPr>
        <p:grpSpPr>
          <a:xfrm>
            <a:off x="2069547" y="110518"/>
            <a:ext cx="4579201" cy="2076951"/>
            <a:chOff x="170584" y="574809"/>
            <a:chExt cx="5376178" cy="2568680"/>
          </a:xfrm>
        </p:grpSpPr>
        <p:pic>
          <p:nvPicPr>
            <p:cNvPr id="3" name="77 Imagen"/>
            <p:cNvPicPr/>
            <p:nvPr/>
          </p:nvPicPr>
          <p:blipFill>
            <a:blip r:embed="rId2"/>
            <a:srcRect t="37091" r="16268" b="3963"/>
            <a:stretch>
              <a:fillRect/>
            </a:stretch>
          </p:blipFill>
          <p:spPr>
            <a:xfrm>
              <a:off x="170584" y="574809"/>
              <a:ext cx="5376178" cy="2568680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4" name="Conector recto 11"/>
            <p:cNvCxnSpPr/>
            <p:nvPr/>
          </p:nvCxnSpPr>
          <p:spPr>
            <a:xfrm>
              <a:off x="5537709" y="733331"/>
              <a:ext cx="0" cy="2154725"/>
            </a:xfrm>
            <a:prstGeom prst="line">
              <a:avLst/>
            </a:prstGeom>
            <a:ln w="1270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upo 5"/>
          <p:cNvGrpSpPr/>
          <p:nvPr/>
        </p:nvGrpSpPr>
        <p:grpSpPr>
          <a:xfrm>
            <a:off x="2160597" y="2317178"/>
            <a:ext cx="4659303" cy="2838450"/>
            <a:chOff x="325925" y="1195287"/>
            <a:chExt cx="7206558" cy="4119326"/>
          </a:xfrm>
        </p:grpSpPr>
        <p:pic>
          <p:nvPicPr>
            <p:cNvPr id="6" name="Imagen 240"/>
            <p:cNvPicPr/>
            <p:nvPr/>
          </p:nvPicPr>
          <p:blipFill rotWithShape="1">
            <a:blip r:embed="rId3"/>
            <a:srcRect l="10824" t="6958" r="6636" b="5204"/>
            <a:stretch/>
          </p:blipFill>
          <p:spPr>
            <a:xfrm>
              <a:off x="325925" y="1195287"/>
              <a:ext cx="7206558" cy="4119326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Imagen 241"/>
            <p:cNvPicPr/>
            <p:nvPr/>
          </p:nvPicPr>
          <p:blipFill>
            <a:blip r:embed="rId4"/>
            <a:srcRect l="-21630" t="11009" r="26013" b="9563"/>
            <a:stretch>
              <a:fillRect/>
            </a:stretch>
          </p:blipFill>
          <p:spPr>
            <a:xfrm>
              <a:off x="2357354" y="1358249"/>
              <a:ext cx="2169378" cy="2341440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Line 1"/>
            <p:cNvSpPr/>
            <p:nvPr/>
          </p:nvSpPr>
          <p:spPr>
            <a:xfrm flipV="1">
              <a:off x="1390933" y="1358249"/>
              <a:ext cx="1705352" cy="50585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</p:sp>
        <p:sp>
          <p:nvSpPr>
            <p:cNvPr id="9" name="Line 2"/>
            <p:cNvSpPr/>
            <p:nvPr/>
          </p:nvSpPr>
          <p:spPr>
            <a:xfrm>
              <a:off x="1390933" y="3096513"/>
              <a:ext cx="1705352" cy="603175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</p:sp>
      </p:grpSp>
      <p:sp>
        <p:nvSpPr>
          <p:cNvPr id="11" name="CuadroTexto 2"/>
          <p:cNvSpPr txBox="1"/>
          <p:nvPr/>
        </p:nvSpPr>
        <p:spPr>
          <a:xfrm>
            <a:off x="1793531" y="157064"/>
            <a:ext cx="37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2" name="CuadroTexto 2"/>
          <p:cNvSpPr txBox="1"/>
          <p:nvPr/>
        </p:nvSpPr>
        <p:spPr>
          <a:xfrm>
            <a:off x="1781656" y="2346214"/>
            <a:ext cx="37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B</a:t>
            </a:r>
            <a:endParaRPr lang="es-ES" dirty="0"/>
          </a:p>
        </p:txBody>
      </p:sp>
      <p:sp>
        <p:nvSpPr>
          <p:cNvPr id="10" name="9 CuadroTexto"/>
          <p:cNvSpPr txBox="1"/>
          <p:nvPr/>
        </p:nvSpPr>
        <p:spPr>
          <a:xfrm rot="16200000">
            <a:off x="1186171" y="3748363"/>
            <a:ext cx="1569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ffold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 rot="16200000">
            <a:off x="1198045" y="935926"/>
            <a:ext cx="1569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P’s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3835448" y="5106855"/>
            <a:ext cx="1569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ffold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ordinate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3390325" y="1954112"/>
            <a:ext cx="1569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ffolds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ángulo 16"/>
          <p:cNvSpPr/>
          <p:nvPr/>
        </p:nvSpPr>
        <p:spPr>
          <a:xfrm>
            <a:off x="636802" y="5419810"/>
            <a:ext cx="7967202" cy="889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.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RRL3631 reads mapping on CBS277.49 genome. (A) Manhattan plot of SNPs density (y-axis) physically mapped on 26 scaffolds of CBS277.49 genome divided in 10 Kb windows (x-axis). (B) Unmapped regions along scaffolds of CBS277.49 genome. Gaps are indicated in red. </a:t>
            </a:r>
            <a:endParaRPr lang="es-E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6942783" y="6360309"/>
            <a:ext cx="1827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28736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73</TotalTime>
  <Words>64</Words>
  <Application>Microsoft Office PowerPoint</Application>
  <PresentationFormat>Presentación en pantalla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Universitat Rovira i Virgil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oida López Fernández</dc:creator>
  <cp:lastModifiedBy>Loida López Fernández</cp:lastModifiedBy>
  <cp:revision>318</cp:revision>
  <cp:lastPrinted>2017-12-05T12:24:16Z</cp:lastPrinted>
  <dcterms:created xsi:type="dcterms:W3CDTF">2016-05-12T10:16:36Z</dcterms:created>
  <dcterms:modified xsi:type="dcterms:W3CDTF">2017-12-05T19:27:30Z</dcterms:modified>
</cp:coreProperties>
</file>